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95" r:id="rId2"/>
    <p:sldId id="296" r:id="rId3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 varScale="1">
        <p:scale>
          <a:sx n="58" d="100"/>
          <a:sy n="58" d="100"/>
        </p:scale>
        <p:origin x="2467" y="6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microsoft.com/office/2007/relationships/hdphoto" Target="../media/hdphoto1.wdp"/><Relationship Id="rId3" Type="http://schemas.openxmlformats.org/officeDocument/2006/relationships/image" Target="../media/image2.tiff"/><Relationship Id="rId21" Type="http://schemas.openxmlformats.org/officeDocument/2006/relationships/image" Target="../media/image18.jpeg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png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microsoft.com/office/2007/relationships/hdphoto" Target="../media/hdphoto2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19.png"/><Relationship Id="rId10" Type="http://schemas.openxmlformats.org/officeDocument/2006/relationships/image" Target="../media/image9.tiff"/><Relationship Id="rId19" Type="http://schemas.openxmlformats.org/officeDocument/2006/relationships/image" Target="../media/image17.jpeg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122572" y="162932"/>
            <a:ext cx="2730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20688" y="761729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03" name="Group 38"/>
          <p:cNvGrpSpPr/>
          <p:nvPr/>
        </p:nvGrpSpPr>
        <p:grpSpPr>
          <a:xfrm>
            <a:off x="875112" y="3038193"/>
            <a:ext cx="1320421" cy="1311157"/>
            <a:chOff x="820537" y="6379996"/>
            <a:chExt cx="1320421" cy="1311157"/>
          </a:xfrm>
        </p:grpSpPr>
        <p:pic>
          <p:nvPicPr>
            <p:cNvPr id="225" name="Picture 3" descr="R:\rsrch\dc17\lab\People\Dorian Swarts\Microscopy\2016-01-26 IF fv tf cycle\transfect\fv-pur-0016e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820537" y="6379996"/>
              <a:ext cx="1320421" cy="13111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6" name="Straight Connector 61"/>
            <p:cNvCxnSpPr/>
            <p:nvPr/>
          </p:nvCxnSpPr>
          <p:spPr>
            <a:xfrm flipV="1">
              <a:off x="844920" y="7617296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4" name="Group 39"/>
          <p:cNvGrpSpPr/>
          <p:nvPr/>
        </p:nvGrpSpPr>
        <p:grpSpPr>
          <a:xfrm>
            <a:off x="2267541" y="3038192"/>
            <a:ext cx="1373996" cy="1304781"/>
            <a:chOff x="2389353" y="6379995"/>
            <a:chExt cx="1373996" cy="1304781"/>
          </a:xfrm>
        </p:grpSpPr>
        <p:pic>
          <p:nvPicPr>
            <p:cNvPr id="223" name="Picture 4" descr="R:\rsrch\dc17\lab\People\Dorian Swarts\Microscopy\2016-01-26 IF fv tf cycle\transfect\fv-pur-0017e.tif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389353" y="6379995"/>
              <a:ext cx="1373996" cy="13047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4" name="Straight Connector 59"/>
            <p:cNvCxnSpPr/>
            <p:nvPr/>
          </p:nvCxnSpPr>
          <p:spPr>
            <a:xfrm flipV="1">
              <a:off x="2437803" y="7615350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5" name="Group 40"/>
          <p:cNvGrpSpPr/>
          <p:nvPr/>
        </p:nvGrpSpPr>
        <p:grpSpPr>
          <a:xfrm>
            <a:off x="5095646" y="3031050"/>
            <a:ext cx="1276351" cy="1297944"/>
            <a:chOff x="5483552" y="6372853"/>
            <a:chExt cx="1276351" cy="1297944"/>
          </a:xfrm>
        </p:grpSpPr>
        <p:pic>
          <p:nvPicPr>
            <p:cNvPr id="221" name="Picture 5" descr="R:\rsrch\dc17\lab\People\Dorian Swarts\Microscopy\2016-01-26 IF fv tf cycle\transfect\fv-pur-0019.t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483552" y="6372853"/>
              <a:ext cx="1276351" cy="12979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2" name="Straight Connector 57"/>
            <p:cNvCxnSpPr/>
            <p:nvPr/>
          </p:nvCxnSpPr>
          <p:spPr>
            <a:xfrm flipV="1">
              <a:off x="5524623" y="7608754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6" name="Group 41"/>
          <p:cNvGrpSpPr/>
          <p:nvPr/>
        </p:nvGrpSpPr>
        <p:grpSpPr>
          <a:xfrm>
            <a:off x="3707701" y="3031050"/>
            <a:ext cx="1314450" cy="1311924"/>
            <a:chOff x="4000499" y="6372853"/>
            <a:chExt cx="1314450" cy="1311924"/>
          </a:xfrm>
        </p:grpSpPr>
        <p:pic>
          <p:nvPicPr>
            <p:cNvPr id="219" name="Picture 2" descr="R:\rsrch\dc17\lab\People\Dorian Swarts\Microscopy\2016-01-26 IF fv tf cycle\transfect\fv-purErg.tif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4000499" y="6372853"/>
              <a:ext cx="1314450" cy="13119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0" name="Straight Connector 55"/>
            <p:cNvCxnSpPr/>
            <p:nvPr/>
          </p:nvCxnSpPr>
          <p:spPr>
            <a:xfrm flipV="1">
              <a:off x="4077072" y="7624137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7" name="Group 42"/>
          <p:cNvGrpSpPr/>
          <p:nvPr/>
        </p:nvGrpSpPr>
        <p:grpSpPr>
          <a:xfrm>
            <a:off x="847210" y="4419509"/>
            <a:ext cx="1348323" cy="1290801"/>
            <a:chOff x="820537" y="8022617"/>
            <a:chExt cx="1348323" cy="1290801"/>
          </a:xfrm>
        </p:grpSpPr>
        <p:pic>
          <p:nvPicPr>
            <p:cNvPr id="217" name="Picture 10" descr="R:\rsrch\dc17\lab\People\Dorian Swarts\Microscopy\2016-01-26 IF fv tf cycle\transfect\FL-pur-0005.ti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820537" y="8022617"/>
              <a:ext cx="1348323" cy="12908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8" name="Straight Connector 53"/>
            <p:cNvCxnSpPr/>
            <p:nvPr/>
          </p:nvCxnSpPr>
          <p:spPr>
            <a:xfrm flipV="1">
              <a:off x="907525" y="9201472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8" name="Group 43"/>
          <p:cNvGrpSpPr/>
          <p:nvPr/>
        </p:nvGrpSpPr>
        <p:grpSpPr>
          <a:xfrm>
            <a:off x="2267541" y="4419509"/>
            <a:ext cx="1373995" cy="1290801"/>
            <a:chOff x="2389354" y="8022617"/>
            <a:chExt cx="1373995" cy="1290801"/>
          </a:xfrm>
        </p:grpSpPr>
        <p:pic>
          <p:nvPicPr>
            <p:cNvPr id="215" name="Picture 8" descr="R:\rsrch\dc17\lab\People\Dorian Swarts\Microscopy\2016-01-26 IF fv tf cycle\transfect\FL-pur-0006e.ti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389354" y="8022617"/>
              <a:ext cx="1373995" cy="12908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6" name="Straight Connector 51"/>
            <p:cNvCxnSpPr/>
            <p:nvPr/>
          </p:nvCxnSpPr>
          <p:spPr>
            <a:xfrm flipV="1">
              <a:off x="2437803" y="9201472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9" name="Group 44"/>
          <p:cNvGrpSpPr/>
          <p:nvPr/>
        </p:nvGrpSpPr>
        <p:grpSpPr>
          <a:xfrm>
            <a:off x="3707701" y="4419509"/>
            <a:ext cx="1307192" cy="1290802"/>
            <a:chOff x="4007757" y="8022616"/>
            <a:chExt cx="1307192" cy="1290802"/>
          </a:xfrm>
        </p:grpSpPr>
        <p:pic>
          <p:nvPicPr>
            <p:cNvPr id="213" name="Picture 6" descr="R:\rsrch\dc17\lab\People\Dorian Swarts\Microscopy\2016-01-26 IF fv tf cycle\transfect\FL-purBrg.tif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4007757" y="8022616"/>
              <a:ext cx="1307192" cy="12908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4" name="Straight Connector 49"/>
            <p:cNvCxnSpPr/>
            <p:nvPr/>
          </p:nvCxnSpPr>
          <p:spPr>
            <a:xfrm flipV="1">
              <a:off x="4067632" y="9225397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0" name="Group 45"/>
          <p:cNvGrpSpPr/>
          <p:nvPr/>
        </p:nvGrpSpPr>
        <p:grpSpPr>
          <a:xfrm>
            <a:off x="5095646" y="4419509"/>
            <a:ext cx="1276351" cy="1290801"/>
            <a:chOff x="5483552" y="8022617"/>
            <a:chExt cx="1276351" cy="1290801"/>
          </a:xfrm>
        </p:grpSpPr>
        <p:pic>
          <p:nvPicPr>
            <p:cNvPr id="211" name="Picture 9" descr="R:\rsrch\dc17\lab\People\Dorian Swarts\Microscopy\2016-01-26 IF fv tf cycle\transfect\FL-pur-0007.tif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483552" y="8022617"/>
              <a:ext cx="1276351" cy="12908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2" name="Straight Connector 47"/>
            <p:cNvCxnSpPr/>
            <p:nvPr/>
          </p:nvCxnSpPr>
          <p:spPr>
            <a:xfrm flipV="1">
              <a:off x="5524623" y="9227343"/>
              <a:ext cx="4966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7" name="TextBox 32"/>
          <p:cNvSpPr txBox="1"/>
          <p:nvPr/>
        </p:nvSpPr>
        <p:spPr>
          <a:xfrm>
            <a:off x="875112" y="2723273"/>
            <a:ext cx="1320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</a:p>
        </p:txBody>
      </p:sp>
      <p:sp>
        <p:nvSpPr>
          <p:cNvPr id="198" name="TextBox 33"/>
          <p:cNvSpPr txBox="1"/>
          <p:nvPr/>
        </p:nvSpPr>
        <p:spPr>
          <a:xfrm>
            <a:off x="152636" y="3577730"/>
            <a:ext cx="840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GFP-CIZ1-F</a:t>
            </a:r>
          </a:p>
        </p:txBody>
      </p:sp>
      <p:sp>
        <p:nvSpPr>
          <p:cNvPr id="199" name="TextBox 34"/>
          <p:cNvSpPr txBox="1"/>
          <p:nvPr/>
        </p:nvSpPr>
        <p:spPr>
          <a:xfrm>
            <a:off x="44624" y="4808984"/>
            <a:ext cx="8767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GFP-full length CIZ1</a:t>
            </a:r>
          </a:p>
        </p:txBody>
      </p:sp>
      <p:sp>
        <p:nvSpPr>
          <p:cNvPr id="200" name="TextBox 35"/>
          <p:cNvSpPr txBox="1"/>
          <p:nvPr/>
        </p:nvSpPr>
        <p:spPr>
          <a:xfrm>
            <a:off x="2073549" y="2720752"/>
            <a:ext cx="1678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ti CIZ1-F</a:t>
            </a:r>
          </a:p>
        </p:txBody>
      </p:sp>
      <p:sp>
        <p:nvSpPr>
          <p:cNvPr id="201" name="TextBox 36"/>
          <p:cNvSpPr txBox="1"/>
          <p:nvPr/>
        </p:nvSpPr>
        <p:spPr>
          <a:xfrm>
            <a:off x="3707702" y="2725564"/>
            <a:ext cx="1307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</a:p>
        </p:txBody>
      </p:sp>
      <p:sp>
        <p:nvSpPr>
          <p:cNvPr id="202" name="TextBox 37"/>
          <p:cNvSpPr txBox="1"/>
          <p:nvPr/>
        </p:nvSpPr>
        <p:spPr>
          <a:xfrm>
            <a:off x="5095647" y="2716824"/>
            <a:ext cx="1276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194" name="Picture 2" descr="C:\Dorian Swarts\Experimental work\Microscopy\2016-01-26 IF fv tf cycle\transfect\fv-pur-0018.tif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178094" y="3930583"/>
            <a:ext cx="449460" cy="404712"/>
          </a:xfrm>
          <a:prstGeom prst="rect">
            <a:avLst/>
          </a:prstGeom>
          <a:noFill/>
          <a:ln>
            <a:solidFill>
              <a:srgbClr val="00B05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28" name="Groep 227"/>
          <p:cNvGrpSpPr>
            <a:grpSpLocks noChangeAspect="1"/>
          </p:cNvGrpSpPr>
          <p:nvPr/>
        </p:nvGrpSpPr>
        <p:grpSpPr>
          <a:xfrm>
            <a:off x="262540" y="814684"/>
            <a:ext cx="4750636" cy="1453114"/>
            <a:chOff x="328073" y="4476621"/>
            <a:chExt cx="5938297" cy="1816391"/>
          </a:xfrm>
        </p:grpSpPr>
        <p:grpSp>
          <p:nvGrpSpPr>
            <p:cNvPr id="229" name="Group 1"/>
            <p:cNvGrpSpPr/>
            <p:nvPr/>
          </p:nvGrpSpPr>
          <p:grpSpPr>
            <a:xfrm>
              <a:off x="1045469" y="5050060"/>
              <a:ext cx="3438499" cy="1242952"/>
              <a:chOff x="1045469" y="5050060"/>
              <a:chExt cx="3438499" cy="1242952"/>
            </a:xfrm>
          </p:grpSpPr>
          <p:pic>
            <p:nvPicPr>
              <p:cNvPr id="247" name="Picture 2" descr="R:\rsrch\dc17\lab\People\Dorian Swarts\pixie\2015-10-30i.tif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2845968" y="5050060"/>
                <a:ext cx="1638000" cy="88883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8" name="Picture 3" descr="R:\rsrch\dc17\lab\People\Dorian Swarts\pixie\2016-02-23d 21s.tif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889" t="21802" r="52222" b="61090"/>
              <a:stretch/>
            </p:blipFill>
            <p:spPr bwMode="auto">
              <a:xfrm>
                <a:off x="1045469" y="5057325"/>
                <a:ext cx="1638301" cy="88156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9" name="Picture 4" descr="R:\rsrch\dc17\lab\People\Dorian Swarts\pixie\2016-02-26c 5s.tif"/>
              <p:cNvPicPr>
                <a:picLocks noChangeAspect="1" noChangeArrowheads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2845968" y="6033120"/>
                <a:ext cx="1638000" cy="25989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230" name="Group 63"/>
            <p:cNvGrpSpPr/>
            <p:nvPr/>
          </p:nvGrpSpPr>
          <p:grpSpPr>
            <a:xfrm>
              <a:off x="328073" y="4476621"/>
              <a:ext cx="5938297" cy="1813535"/>
              <a:chOff x="328073" y="4476621"/>
              <a:chExt cx="5938297" cy="1813535"/>
            </a:xfrm>
          </p:grpSpPr>
          <p:grpSp>
            <p:nvGrpSpPr>
              <p:cNvPr id="231" name="Group 2"/>
              <p:cNvGrpSpPr/>
              <p:nvPr/>
            </p:nvGrpSpPr>
            <p:grpSpPr>
              <a:xfrm>
                <a:off x="328073" y="4476621"/>
                <a:ext cx="4684263" cy="1813535"/>
                <a:chOff x="328073" y="4476621"/>
                <a:chExt cx="4684263" cy="1813535"/>
              </a:xfrm>
            </p:grpSpPr>
            <p:grpSp>
              <p:nvGrpSpPr>
                <p:cNvPr id="236" name="Group 12"/>
                <p:cNvGrpSpPr/>
                <p:nvPr/>
              </p:nvGrpSpPr>
              <p:grpSpPr>
                <a:xfrm>
                  <a:off x="454716" y="4476621"/>
                  <a:ext cx="4198422" cy="1813535"/>
                  <a:chOff x="84804" y="3538743"/>
                  <a:chExt cx="4198422" cy="1813535"/>
                </a:xfrm>
              </p:grpSpPr>
              <p:sp>
                <p:nvSpPr>
                  <p:cNvPr id="244" name="TextBox 20"/>
                  <p:cNvSpPr txBox="1"/>
                  <p:nvPr/>
                </p:nvSpPr>
                <p:spPr>
                  <a:xfrm>
                    <a:off x="548680" y="3538745"/>
                    <a:ext cx="1827776" cy="3077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IZ1 exon 5 antibody</a:t>
                    </a:r>
                  </a:p>
                </p:txBody>
              </p:sp>
              <p:sp>
                <p:nvSpPr>
                  <p:cNvPr id="245" name="TextBox 21"/>
                  <p:cNvSpPr txBox="1"/>
                  <p:nvPr/>
                </p:nvSpPr>
                <p:spPr>
                  <a:xfrm>
                    <a:off x="2313858" y="3538743"/>
                    <a:ext cx="1969368" cy="3077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IZ1-F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body</a:t>
                    </a:r>
                  </a:p>
                </p:txBody>
              </p:sp>
              <p:sp>
                <p:nvSpPr>
                  <p:cNvPr id="246" name="TextBox 22"/>
                  <p:cNvSpPr txBox="1"/>
                  <p:nvPr/>
                </p:nvSpPr>
                <p:spPr>
                  <a:xfrm>
                    <a:off x="84804" y="5044502"/>
                    <a:ext cx="605123" cy="3077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tin</a:t>
                    </a:r>
                  </a:p>
                </p:txBody>
              </p:sp>
            </p:grpSp>
            <p:grpSp>
              <p:nvGrpSpPr>
                <p:cNvPr id="237" name="Group 13"/>
                <p:cNvGrpSpPr/>
                <p:nvPr/>
              </p:nvGrpSpPr>
              <p:grpSpPr>
                <a:xfrm>
                  <a:off x="328073" y="4763398"/>
                  <a:ext cx="4684263" cy="1219232"/>
                  <a:chOff x="-41839" y="3825520"/>
                  <a:chExt cx="4684263" cy="1219232"/>
                </a:xfrm>
              </p:grpSpPr>
              <p:sp>
                <p:nvSpPr>
                  <p:cNvPr id="238" name="TextBox 14"/>
                  <p:cNvSpPr txBox="1"/>
                  <p:nvPr/>
                </p:nvSpPr>
                <p:spPr>
                  <a:xfrm>
                    <a:off x="663864" y="3825520"/>
                    <a:ext cx="1829461" cy="3077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-   GFP    </a:t>
                    </a:r>
                    <a:r>
                      <a:rPr lang="en-GB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FL</a:t>
                    </a:r>
                  </a:p>
                </p:txBody>
              </p:sp>
              <p:sp>
                <p:nvSpPr>
                  <p:cNvPr id="239" name="TextBox 15"/>
                  <p:cNvSpPr txBox="1"/>
                  <p:nvPr/>
                </p:nvSpPr>
                <p:spPr>
                  <a:xfrm>
                    <a:off x="2554193" y="3825520"/>
                    <a:ext cx="2088231" cy="3077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   GFP    </a:t>
                    </a:r>
                    <a:r>
                      <a:rPr lang="en-GB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v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FL</a:t>
                    </a:r>
                  </a:p>
                </p:txBody>
              </p:sp>
              <p:grpSp>
                <p:nvGrpSpPr>
                  <p:cNvPr id="240" name="Group 16"/>
                  <p:cNvGrpSpPr/>
                  <p:nvPr/>
                </p:nvGrpSpPr>
                <p:grpSpPr>
                  <a:xfrm>
                    <a:off x="-41839" y="4115326"/>
                    <a:ext cx="754982" cy="929426"/>
                    <a:chOff x="-41839" y="4115326"/>
                    <a:chExt cx="754982" cy="929426"/>
                  </a:xfrm>
                </p:grpSpPr>
                <p:sp>
                  <p:nvSpPr>
                    <p:cNvPr id="241" name="TextBox 17"/>
                    <p:cNvSpPr txBox="1"/>
                    <p:nvPr/>
                  </p:nvSpPr>
                  <p:spPr>
                    <a:xfrm>
                      <a:off x="44623" y="4736976"/>
                      <a:ext cx="668520" cy="3077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kD</a:t>
                      </a:r>
                    </a:p>
                  </p:txBody>
                </p:sp>
                <p:sp>
                  <p:nvSpPr>
                    <p:cNvPr id="242" name="TextBox 18"/>
                    <p:cNvSpPr txBox="1"/>
                    <p:nvPr/>
                  </p:nvSpPr>
                  <p:spPr>
                    <a:xfrm>
                      <a:off x="-41839" y="4376936"/>
                      <a:ext cx="754982" cy="3077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kD</a:t>
                      </a:r>
                    </a:p>
                  </p:txBody>
                </p:sp>
                <p:sp>
                  <p:nvSpPr>
                    <p:cNvPr id="243" name="TextBox 19"/>
                    <p:cNvSpPr txBox="1"/>
                    <p:nvPr/>
                  </p:nvSpPr>
                  <p:spPr>
                    <a:xfrm>
                      <a:off x="-41839" y="4115326"/>
                      <a:ext cx="754982" cy="3077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kD</a:t>
                      </a:r>
                    </a:p>
                  </p:txBody>
                </p:sp>
              </p:grpSp>
            </p:grpSp>
          </p:grpSp>
          <p:sp>
            <p:nvSpPr>
              <p:cNvPr id="232" name="TextBox 7"/>
              <p:cNvSpPr txBox="1"/>
              <p:nvPr/>
            </p:nvSpPr>
            <p:spPr>
              <a:xfrm>
                <a:off x="4939093" y="4961934"/>
                <a:ext cx="1142599" cy="5001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/>
                    <a:cs typeface="Arial"/>
                  </a:rPr>
                  <a:t>EGFP-full length CIZ1</a:t>
                </a:r>
              </a:p>
            </p:txBody>
          </p:sp>
          <p:sp>
            <p:nvSpPr>
              <p:cNvPr id="233" name="TextBox 8"/>
              <p:cNvSpPr txBox="1"/>
              <p:nvPr/>
            </p:nvSpPr>
            <p:spPr>
              <a:xfrm>
                <a:off x="4943171" y="5599065"/>
                <a:ext cx="1323199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/>
                    <a:cs typeface="Arial"/>
                  </a:rPr>
                  <a:t>EGFP-CIZ1-F</a:t>
                </a:r>
              </a:p>
            </p:txBody>
          </p:sp>
          <p:cxnSp>
            <p:nvCxnSpPr>
              <p:cNvPr id="234" name="Straight Arrow Connector 9"/>
              <p:cNvCxnSpPr/>
              <p:nvPr/>
            </p:nvCxnSpPr>
            <p:spPr>
              <a:xfrm flipH="1">
                <a:off x="4581128" y="5195824"/>
                <a:ext cx="324255" cy="0"/>
              </a:xfrm>
              <a:prstGeom prst="straightConnector1">
                <a:avLst/>
              </a:prstGeom>
              <a:ln w="25400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Arrow Connector 10"/>
              <p:cNvCxnSpPr/>
              <p:nvPr/>
            </p:nvCxnSpPr>
            <p:spPr>
              <a:xfrm flipH="1">
                <a:off x="4581128" y="5775638"/>
                <a:ext cx="324255" cy="0"/>
              </a:xfrm>
              <a:prstGeom prst="straightConnector1">
                <a:avLst/>
              </a:prstGeom>
              <a:ln w="25400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51" name="TextBox 36"/>
          <p:cNvSpPr txBox="1"/>
          <p:nvPr/>
        </p:nvSpPr>
        <p:spPr>
          <a:xfrm>
            <a:off x="620688" y="609291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7" name="TextBox 36"/>
          <p:cNvSpPr txBox="1"/>
          <p:nvPr/>
        </p:nvSpPr>
        <p:spPr>
          <a:xfrm>
            <a:off x="620688" y="257673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11" name="Groep 1"/>
          <p:cNvGrpSpPr/>
          <p:nvPr/>
        </p:nvGrpSpPr>
        <p:grpSpPr>
          <a:xfrm>
            <a:off x="764233" y="7905526"/>
            <a:ext cx="3872766" cy="1800002"/>
            <a:chOff x="3201202" y="6315342"/>
            <a:chExt cx="3872766" cy="1800002"/>
          </a:xfrm>
        </p:grpSpPr>
        <p:pic>
          <p:nvPicPr>
            <p:cNvPr id="115" name="Picture 2" descr="C:\Dorian Swarts\Experimental work\Microscopy\Images made by Emma\FVar_ER\DNase\DNaseA.tif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rot="16200000">
              <a:off x="5539617" y="6580992"/>
              <a:ext cx="1800000" cy="12687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6" name="Picture 115" descr="C:\Dorian Swarts\Experimental work\Microscopy\Images made by Emma\FVar_ER\DNase\DNase2e.tif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219" r="48634"/>
            <a:stretch/>
          </p:blipFill>
          <p:spPr bwMode="auto">
            <a:xfrm rot="16200000">
              <a:off x="2915354" y="6601191"/>
              <a:ext cx="1800000" cy="12283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7" name="Picture 4" descr="C:\Dorian Swarts\Experimental work\Microscopy\Images made by Emma\FVar_ER\DNase\DNase4e.tif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780" r="50000"/>
            <a:stretch/>
          </p:blipFill>
          <p:spPr bwMode="auto">
            <a:xfrm rot="16200000">
              <a:off x="4213378" y="6578490"/>
              <a:ext cx="1800000" cy="12737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12" name="TextBox 111"/>
          <p:cNvSpPr txBox="1"/>
          <p:nvPr/>
        </p:nvSpPr>
        <p:spPr>
          <a:xfrm>
            <a:off x="898901" y="9417496"/>
            <a:ext cx="1228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Z1-F</a:t>
            </a:r>
          </a:p>
        </p:txBody>
      </p:sp>
      <p:grpSp>
        <p:nvGrpSpPr>
          <p:cNvPr id="104" name="Group 103"/>
          <p:cNvGrpSpPr/>
          <p:nvPr/>
        </p:nvGrpSpPr>
        <p:grpSpPr>
          <a:xfrm>
            <a:off x="3421225" y="7905527"/>
            <a:ext cx="1500304" cy="898605"/>
            <a:chOff x="3215020" y="6557120"/>
            <a:chExt cx="1500304" cy="898605"/>
          </a:xfrm>
        </p:grpSpPr>
        <p:sp>
          <p:nvSpPr>
            <p:cNvPr id="108" name="Rectangle 28">
              <a:extLst>
                <a:ext uri="{FF2B5EF4-FFF2-40B4-BE49-F238E27FC236}">
                  <a16:creationId xmlns:a16="http://schemas.microsoft.com/office/drawing/2014/main" id="{854220E3-9A0C-490E-9E89-0FFAE8624755}"/>
                </a:ext>
              </a:extLst>
            </p:cNvPr>
            <p:cNvSpPr/>
            <p:nvPr/>
          </p:nvSpPr>
          <p:spPr>
            <a:xfrm>
              <a:off x="3215020" y="6665826"/>
              <a:ext cx="470375" cy="491399"/>
            </a:xfrm>
            <a:prstGeom prst="rect">
              <a:avLst/>
            </a:prstGeom>
            <a:noFill/>
            <a:ln w="952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30">
              <a:extLst>
                <a:ext uri="{FF2B5EF4-FFF2-40B4-BE49-F238E27FC236}">
                  <a16:creationId xmlns:a16="http://schemas.microsoft.com/office/drawing/2014/main" id="{99672DF8-2E87-4626-8FF0-647DCFB080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88251" y="6557120"/>
              <a:ext cx="1027073" cy="108706"/>
            </a:xfrm>
            <a:prstGeom prst="line">
              <a:avLst/>
            </a:prstGeom>
            <a:ln w="12700" cmpd="sng">
              <a:solidFill>
                <a:srgbClr val="00B050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31">
              <a:extLst>
                <a:ext uri="{FF2B5EF4-FFF2-40B4-BE49-F238E27FC236}">
                  <a16:creationId xmlns:a16="http://schemas.microsoft.com/office/drawing/2014/main" id="{62CE7CA7-769A-42CF-B1F1-572EEA5FBFDB}"/>
                </a:ext>
              </a:extLst>
            </p:cNvPr>
            <p:cNvCxnSpPr>
              <a:cxnSpLocks/>
            </p:cNvCxnSpPr>
            <p:nvPr/>
          </p:nvCxnSpPr>
          <p:spPr>
            <a:xfrm>
              <a:off x="3685396" y="7157225"/>
              <a:ext cx="1029928" cy="298500"/>
            </a:xfrm>
            <a:prstGeom prst="line">
              <a:avLst/>
            </a:prstGeom>
            <a:ln w="12700" cmpd="sng">
              <a:solidFill>
                <a:srgbClr val="00B050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5" name="Group 104"/>
          <p:cNvGrpSpPr/>
          <p:nvPr/>
        </p:nvGrpSpPr>
        <p:grpSpPr>
          <a:xfrm>
            <a:off x="4921529" y="7921687"/>
            <a:ext cx="883735" cy="900000"/>
            <a:chOff x="5065544" y="8493256"/>
            <a:chExt cx="883735" cy="900000"/>
          </a:xfrm>
        </p:grpSpPr>
        <p:pic>
          <p:nvPicPr>
            <p:cNvPr id="106" name="Picture 2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5057412" y="8501388"/>
              <a:ext cx="900000" cy="883735"/>
            </a:xfrm>
            <a:prstGeom prst="rect">
              <a:avLst/>
            </a:prstGeom>
            <a:noFill/>
            <a:ln w="9525">
              <a:solidFill>
                <a:srgbClr val="00B05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cxnSp>
          <p:nvCxnSpPr>
            <p:cNvPr id="107" name="Straight Connector 154">
              <a:extLst>
                <a:ext uri="{FF2B5EF4-FFF2-40B4-BE49-F238E27FC236}">
                  <a16:creationId xmlns:a16="http://schemas.microsoft.com/office/drawing/2014/main" id="{9045D71D-09CE-473B-8B61-6F2D62A4E198}"/>
                </a:ext>
              </a:extLst>
            </p:cNvPr>
            <p:cNvCxnSpPr/>
            <p:nvPr/>
          </p:nvCxnSpPr>
          <p:spPr>
            <a:xfrm flipV="1">
              <a:off x="5157192" y="9321248"/>
              <a:ext cx="55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655275" y="6133486"/>
            <a:ext cx="2067582" cy="1333074"/>
            <a:chOff x="404083" y="2499659"/>
            <a:chExt cx="2067582" cy="1333074"/>
          </a:xfrm>
        </p:grpSpPr>
        <p:grpSp>
          <p:nvGrpSpPr>
            <p:cNvPr id="80" name="Group 79"/>
            <p:cNvGrpSpPr/>
            <p:nvPr/>
          </p:nvGrpSpPr>
          <p:grpSpPr>
            <a:xfrm>
              <a:off x="404083" y="2499659"/>
              <a:ext cx="1595344" cy="1333074"/>
              <a:chOff x="1187624" y="1526595"/>
              <a:chExt cx="1595344" cy="1333074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E48DCA70-C821-2642-93BC-9E3A5E9A68A8}"/>
                  </a:ext>
                </a:extLst>
              </p:cNvPr>
              <p:cNvGrpSpPr/>
              <p:nvPr/>
            </p:nvGrpSpPr>
            <p:grpSpPr>
              <a:xfrm>
                <a:off x="1187624" y="1526595"/>
                <a:ext cx="1595344" cy="1333074"/>
                <a:chOff x="3234195" y="2070882"/>
                <a:chExt cx="1595344" cy="1333074"/>
              </a:xfrm>
            </p:grpSpPr>
            <p:pic>
              <p:nvPicPr>
                <p:cNvPr id="86" name="Picture 85">
                  <a:extLst>
                    <a:ext uri="{FF2B5EF4-FFF2-40B4-BE49-F238E27FC236}">
                      <a16:creationId xmlns:a16="http://schemas.microsoft.com/office/drawing/2014/main" id="{27C1D26F-5D13-4E47-A85C-411118AE8F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4236969" y="2301521"/>
                  <a:ext cx="293370" cy="890716"/>
                </a:xfrm>
                <a:prstGeom prst="rect">
                  <a:avLst/>
                </a:prstGeom>
              </p:spPr>
            </p:pic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1F0AB8A2-CFFE-474F-BB0C-2E1DCD6A5DA1}"/>
                    </a:ext>
                  </a:extLst>
                </p:cNvPr>
                <p:cNvSpPr txBox="1"/>
                <p:nvPr/>
              </p:nvSpPr>
              <p:spPr>
                <a:xfrm>
                  <a:off x="3436964" y="2402222"/>
                  <a:ext cx="4828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70kD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A35C2213-1CAB-5342-A188-9126B865EBA1}"/>
                    </a:ext>
                  </a:extLst>
                </p:cNvPr>
                <p:cNvSpPr txBox="1"/>
                <p:nvPr/>
              </p:nvSpPr>
              <p:spPr>
                <a:xfrm>
                  <a:off x="3234195" y="2178411"/>
                  <a:ext cx="67980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100kD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B1180C47-4DA6-D34A-A9CF-77AFD2A0C848}"/>
                    </a:ext>
                  </a:extLst>
                </p:cNvPr>
                <p:cNvSpPr txBox="1"/>
                <p:nvPr/>
              </p:nvSpPr>
              <p:spPr>
                <a:xfrm>
                  <a:off x="3436964" y="2645708"/>
                  <a:ext cx="4828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55kD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ECD10413-DE9F-A945-8BB1-A57B2D0EE774}"/>
                    </a:ext>
                  </a:extLst>
                </p:cNvPr>
                <p:cNvSpPr txBox="1"/>
                <p:nvPr/>
              </p:nvSpPr>
              <p:spPr>
                <a:xfrm>
                  <a:off x="3441446" y="3157735"/>
                  <a:ext cx="4828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35kD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2DC5138E-9C99-E044-9AC7-85A79009E597}"/>
                    </a:ext>
                  </a:extLst>
                </p:cNvPr>
                <p:cNvSpPr txBox="1"/>
                <p:nvPr/>
              </p:nvSpPr>
              <p:spPr>
                <a:xfrm>
                  <a:off x="3881437" y="2070882"/>
                  <a:ext cx="3129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-P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D50B7DF6-2C60-4B4C-B8B3-C6CD839E1FCC}"/>
                    </a:ext>
                  </a:extLst>
                </p:cNvPr>
                <p:cNvSpPr txBox="1"/>
                <p:nvPr/>
              </p:nvSpPr>
              <p:spPr>
                <a:xfrm>
                  <a:off x="4242307" y="2070882"/>
                  <a:ext cx="3449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+P</a:t>
                  </a:r>
                </a:p>
              </p:txBody>
            </p:sp>
            <p:cxnSp>
              <p:nvCxnSpPr>
                <p:cNvPr id="94" name="Straight Arrow Connector 93">
                  <a:extLst>
                    <a:ext uri="{FF2B5EF4-FFF2-40B4-BE49-F238E27FC236}">
                      <a16:creationId xmlns:a16="http://schemas.microsoft.com/office/drawing/2014/main" id="{D2A6AA77-ADF5-7B4F-9E55-9FBE033AC565}"/>
                    </a:ext>
                  </a:extLst>
                </p:cNvPr>
                <p:cNvCxnSpPr/>
                <p:nvPr/>
              </p:nvCxnSpPr>
              <p:spPr>
                <a:xfrm flipH="1">
                  <a:off x="4547042" y="2444550"/>
                  <a:ext cx="28249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Arrow Connector 94">
                  <a:extLst>
                    <a:ext uri="{FF2B5EF4-FFF2-40B4-BE49-F238E27FC236}">
                      <a16:creationId xmlns:a16="http://schemas.microsoft.com/office/drawing/2014/main" id="{D2C21229-3442-284B-A237-DE3800005152}"/>
                    </a:ext>
                  </a:extLst>
                </p:cNvPr>
                <p:cNvCxnSpPr/>
                <p:nvPr/>
              </p:nvCxnSpPr>
              <p:spPr>
                <a:xfrm flipH="1">
                  <a:off x="4547042" y="3090327"/>
                  <a:ext cx="28249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id="{27C1D26F-5D13-4E47-A85C-411118AE8F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835696" y="1757233"/>
                <a:ext cx="270510" cy="890717"/>
              </a:xfrm>
              <a:prstGeom prst="rect">
                <a:avLst/>
              </a:prstGeom>
            </p:spPr>
          </p:pic>
        </p:grp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F0AB8A2-CFFE-474F-BB0C-2E1DCD6A5DA1}"/>
                </a:ext>
              </a:extLst>
            </p:cNvPr>
            <p:cNvSpPr txBox="1"/>
            <p:nvPr/>
          </p:nvSpPr>
          <p:spPr>
            <a:xfrm>
              <a:off x="1988840" y="2745880"/>
              <a:ext cx="4828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71kD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1F0AB8A2-CFFE-474F-BB0C-2E1DCD6A5DA1}"/>
                </a:ext>
              </a:extLst>
            </p:cNvPr>
            <p:cNvSpPr txBox="1"/>
            <p:nvPr/>
          </p:nvSpPr>
          <p:spPr>
            <a:xfrm>
              <a:off x="1988840" y="3410635"/>
              <a:ext cx="4828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42kD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2960112" y="5987760"/>
            <a:ext cx="2160240" cy="1701544"/>
            <a:chOff x="2708920" y="2353933"/>
            <a:chExt cx="2160240" cy="1701544"/>
          </a:xfrm>
        </p:grpSpPr>
        <p:grpSp>
          <p:nvGrpSpPr>
            <p:cNvPr id="8" name="Group 7"/>
            <p:cNvGrpSpPr/>
            <p:nvPr/>
          </p:nvGrpSpPr>
          <p:grpSpPr>
            <a:xfrm>
              <a:off x="2708920" y="2353933"/>
              <a:ext cx="2160240" cy="1518947"/>
              <a:chOff x="2204864" y="2072680"/>
              <a:chExt cx="2160240" cy="1518947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204864" y="2072680"/>
                <a:ext cx="2160240" cy="1442228"/>
                <a:chOff x="2204864" y="2072680"/>
                <a:chExt cx="2160240" cy="1442228"/>
              </a:xfrm>
            </p:grpSpPr>
            <p:pic>
              <p:nvPicPr>
                <p:cNvPr id="96" name="Picture 2"/>
                <p:cNvPicPr>
                  <a:picLocks noChangeAspect="1" noChangeArrowheads="1"/>
                </p:cNvPicPr>
                <p:nvPr/>
              </p:nvPicPr>
              <p:blipFill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65104" y="2144688"/>
                  <a:ext cx="1800000" cy="137022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A35C2213-1CAB-5342-A188-9126B865EBA1}"/>
                    </a:ext>
                  </a:extLst>
                </p:cNvPr>
                <p:cNvSpPr txBox="1"/>
                <p:nvPr/>
              </p:nvSpPr>
              <p:spPr>
                <a:xfrm>
                  <a:off x="2352588" y="2072680"/>
                  <a:ext cx="356331" cy="14157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7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6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5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4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3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20</a:t>
                  </a: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10</a:t>
                  </a:r>
                </a:p>
                <a:p>
                  <a:pPr algn="r"/>
                  <a:endParaRPr lang="en-US" sz="100" dirty="0">
                    <a:latin typeface="Arial" pitchFamily="34" charset="0"/>
                    <a:cs typeface="Arial" pitchFamily="34" charset="0"/>
                  </a:endParaRPr>
                </a:p>
                <a:p>
                  <a:pPr algn="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A35C2213-1CAB-5342-A188-9126B865EBA1}"/>
                    </a:ext>
                  </a:extLst>
                </p:cNvPr>
                <p:cNvSpPr txBox="1"/>
                <p:nvPr/>
              </p:nvSpPr>
              <p:spPr>
                <a:xfrm rot="16200000">
                  <a:off x="1663742" y="2641025"/>
                  <a:ext cx="132846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Arbitrary values</a:t>
                  </a:r>
                </a:p>
              </p:txBody>
            </p:sp>
          </p:grp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35C2213-1CAB-5342-A188-9126B865EBA1}"/>
                  </a:ext>
                </a:extLst>
              </p:cNvPr>
              <p:cNvSpPr txBox="1"/>
              <p:nvPr/>
            </p:nvSpPr>
            <p:spPr>
              <a:xfrm>
                <a:off x="2780928" y="3345406"/>
                <a:ext cx="15841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1         2          3         4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A35C2213-1CAB-5342-A188-9126B865EBA1}"/>
                  </a:ext>
                </a:extLst>
              </p:cNvPr>
              <p:cNvSpPr txBox="1"/>
              <p:nvPr/>
            </p:nvSpPr>
            <p:spPr>
              <a:xfrm>
                <a:off x="3109232" y="2124000"/>
                <a:ext cx="67980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-P</a:t>
                </a:r>
              </a:p>
              <a:p>
                <a:r>
                  <a:rPr lang="en-US" sz="1000" dirty="0">
                    <a:latin typeface="Arial" pitchFamily="34" charset="0"/>
                    <a:cs typeface="Arial" pitchFamily="34" charset="0"/>
                  </a:rPr>
                  <a:t>+P</a:t>
                </a: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F0AB8A2-CFFE-474F-BB0C-2E1DCD6A5DA1}"/>
                </a:ext>
              </a:extLst>
            </p:cNvPr>
            <p:cNvSpPr txBox="1"/>
            <p:nvPr/>
          </p:nvSpPr>
          <p:spPr>
            <a:xfrm>
              <a:off x="3284984" y="3809256"/>
              <a:ext cx="15219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Band</a:t>
              </a:r>
            </a:p>
          </p:txBody>
        </p:sp>
      </p:grpSp>
      <p:sp>
        <p:nvSpPr>
          <p:cNvPr id="130" name="TextBox 129"/>
          <p:cNvSpPr txBox="1"/>
          <p:nvPr/>
        </p:nvSpPr>
        <p:spPr>
          <a:xfrm>
            <a:off x="620688" y="54442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2160885" y="9428529"/>
            <a:ext cx="1243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21FF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200" dirty="0">
                <a:solidFill>
                  <a:srgbClr val="21FF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dirty="0">
              <a:solidFill>
                <a:srgbClr val="21FF0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533875" y="9397751"/>
            <a:ext cx="1253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</a:p>
        </p:txBody>
      </p:sp>
      <p:pic>
        <p:nvPicPr>
          <p:cNvPr id="9" name="Afbeelding 8">
            <a:extLst>
              <a:ext uri="{FF2B5EF4-FFF2-40B4-BE49-F238E27FC236}">
                <a16:creationId xmlns:a16="http://schemas.microsoft.com/office/drawing/2014/main" id="{A3D54D57-EA00-47D6-8698-2D6DC020DE1C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94" t="37826" r="8592" b="58834"/>
          <a:stretch/>
        </p:blipFill>
        <p:spPr>
          <a:xfrm>
            <a:off x="836457" y="2107611"/>
            <a:ext cx="1320421" cy="15333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3588183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04664" y="416496"/>
            <a:ext cx="6048672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Figure 2. Validation of CIZ1-F antibodies, and relation of CIZ1-F to ERα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A) Western blots showing whole cell lysates from MCF-7 cells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untransfected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(-), or transiently transfected with empty vector (GFP), EGFP-CIZ1-F or EGFP-full-length CIZ1. Lysates were probed with an antibody that recognizes an epitope in exon 5 (left), or affinity-purified CIZ1-F-specific polyclonal antibody (right). Actin is shown as a loading control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B) MCF-7 cells transfected with EGFP-full-length CIZ1 or EGFP-CIZ1-F were harvested after 24 h and washed with detergent-cytoskeletal buffer before fixation. Affinity purified CIZ1-F antibody reacted with ectopically expressed CIZ1-F but not full-length CIZ1. The image of CIZ1-F antibody on CIZ1-F-transfected cells was taken at a lower exposure time than the rest of the panel, with comparable exposure inset. Note that ectopic CIZ1-F aggregates into large foci, which is not seen with endogenous protein. Bars are 10 microns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C) Western blots showing whole cell lysates from MCF7 cells probed with the affinity-purified CIZ1-F -specific polyclonal antibody with (+P) or without (-P) blocking peptides. The panel on the right shows quantifications of the four bands detected on the Western blots (1~71kD, 2~55kD, 3~46kD, 4~42kD) after background subtraction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Immunolocalizatio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of CIZ1-F and ERα in MCF-7 cells after NM extraction using detergent-containing cytoskeleton buffer, followed by 0.5 M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NaCl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then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DNase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 The overlay image does not support CIZ1-F /ERα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olocalisatio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(see enhanced nucleus, boxed). Bar is 10 microns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nl-NL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611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18</TotalTime>
  <Words>347</Words>
  <Application>Microsoft Office PowerPoint</Application>
  <PresentationFormat>A4 Paper (210x297 mm)</PresentationFormat>
  <Paragraphs>5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he University of Yo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Swarts</cp:lastModifiedBy>
  <cp:revision>849</cp:revision>
  <cp:lastPrinted>2016-03-07T16:44:20Z</cp:lastPrinted>
  <dcterms:created xsi:type="dcterms:W3CDTF">2014-11-24T16:22:39Z</dcterms:created>
  <dcterms:modified xsi:type="dcterms:W3CDTF">2018-08-29T21:20:02Z</dcterms:modified>
</cp:coreProperties>
</file>